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1470" y="-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522623825138695"/>
          <c:y val="5.1400554097404488E-2"/>
          <c:w val="0.76523357815568227"/>
          <c:h val="0.80947142023913676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1!$C$5:$C$6</c:f>
              <c:strCache>
                <c:ptCount val="1"/>
                <c:pt idx="0">
                  <c:v>443 Contro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17:$C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70710678118654757</c:v>
                  </c:pt>
                  <c:pt idx="3">
                    <c:v>3.5355339059327378</c:v>
                  </c:pt>
                  <c:pt idx="4">
                    <c:v>4.9497474683058327</c:v>
                  </c:pt>
                  <c:pt idx="5">
                    <c:v>5.6568542494923806</c:v>
                  </c:pt>
                  <c:pt idx="6">
                    <c:v>3.5355339059327378</c:v>
                  </c:pt>
                </c:numCache>
              </c:numRef>
            </c:plus>
            <c:minus>
              <c:numRef>
                <c:f>Sheet1!$C$17:$C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70710678118654757</c:v>
                  </c:pt>
                  <c:pt idx="3">
                    <c:v>3.5355339059327378</c:v>
                  </c:pt>
                  <c:pt idx="4">
                    <c:v>4.9497474683058327</c:v>
                  </c:pt>
                  <c:pt idx="5">
                    <c:v>5.6568542494923806</c:v>
                  </c:pt>
                  <c:pt idx="6">
                    <c:v>3.5355339059327378</c:v>
                  </c:pt>
                </c:numCache>
              </c:numRef>
            </c:minus>
          </c:errBars>
          <c:xVal>
            <c:numRef>
              <c:f>Sheet1!$B$7:$B$15</c:f>
              <c:numCache>
                <c:formatCode>General</c:formatCode>
                <c:ptCount val="9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</c:numCache>
            </c:numRef>
          </c:xVal>
          <c:yVal>
            <c:numRef>
              <c:f>Sheet1!$C$7:$C$15</c:f>
              <c:numCache>
                <c:formatCode>General</c:formatCode>
                <c:ptCount val="9"/>
                <c:pt idx="0">
                  <c:v>0</c:v>
                </c:pt>
                <c:pt idx="1">
                  <c:v>8.3333333333333357</c:v>
                </c:pt>
                <c:pt idx="2">
                  <c:v>16.666666666666664</c:v>
                </c:pt>
                <c:pt idx="3">
                  <c:v>45.333333333333329</c:v>
                </c:pt>
                <c:pt idx="4">
                  <c:v>92</c:v>
                </c:pt>
                <c:pt idx="5">
                  <c:v>96.666666666666671</c:v>
                </c:pt>
                <c:pt idx="6">
                  <c:v>104.33333333333334</c:v>
                </c:pt>
                <c:pt idx="7">
                  <c:v>104</c:v>
                </c:pt>
                <c:pt idx="8">
                  <c:v>106.66666666666666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Sheet1!$D$5:$D$6</c:f>
              <c:strCache>
                <c:ptCount val="1"/>
                <c:pt idx="0">
                  <c:v>443 1mM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E$17:$E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3137084989847401</c:v>
                  </c:pt>
                  <c:pt idx="2">
                    <c:v>0.87436867076455804</c:v>
                  </c:pt>
                  <c:pt idx="3">
                    <c:v>1.43502884254436</c:v>
                  </c:pt>
                  <c:pt idx="4">
                    <c:v>2.8284271247461903</c:v>
                  </c:pt>
                  <c:pt idx="5">
                    <c:v>4.9497474683058327</c:v>
                  </c:pt>
                  <c:pt idx="6">
                    <c:v>5.6568542494923806</c:v>
                  </c:pt>
                </c:numCache>
              </c:numRef>
            </c:plus>
            <c:minus>
              <c:numRef>
                <c:f>Sheet1!$E$17:$E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3137084989847401</c:v>
                  </c:pt>
                  <c:pt idx="2">
                    <c:v>0.87436867076455804</c:v>
                  </c:pt>
                  <c:pt idx="3">
                    <c:v>1.43502884254436</c:v>
                  </c:pt>
                  <c:pt idx="4">
                    <c:v>2.8284271247461903</c:v>
                  </c:pt>
                  <c:pt idx="5">
                    <c:v>4.9497474683058327</c:v>
                  </c:pt>
                  <c:pt idx="6">
                    <c:v>5.6568542494923806</c:v>
                  </c:pt>
                </c:numCache>
              </c:numRef>
            </c:minus>
          </c:errBars>
          <c:xVal>
            <c:numRef>
              <c:f>Sheet1!$B$7:$B$15</c:f>
              <c:numCache>
                <c:formatCode>General</c:formatCode>
                <c:ptCount val="9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</c:numCache>
            </c:numRef>
          </c:xVal>
          <c:yVal>
            <c:numRef>
              <c:f>Sheet1!$D$7:$D$15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6</c:v>
                </c:pt>
                <c:pt idx="5">
                  <c:v>19</c:v>
                </c:pt>
                <c:pt idx="6">
                  <c:v>48.5</c:v>
                </c:pt>
                <c:pt idx="7">
                  <c:v>57</c:v>
                </c:pt>
                <c:pt idx="8">
                  <c:v>63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Sheet1!$E$5:$E$6</c:f>
              <c:strCache>
                <c:ptCount val="1"/>
                <c:pt idx="0">
                  <c:v>441 Contro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D$17:$D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2.8284271247461903</c:v>
                  </c:pt>
                  <c:pt idx="5">
                    <c:v>0.94974746830583001</c:v>
                  </c:pt>
                  <c:pt idx="6">
                    <c:v>1.6568542494923799</c:v>
                  </c:pt>
                </c:numCache>
              </c:numRef>
            </c:plus>
            <c:minus>
              <c:numRef>
                <c:f>Sheet1!$D$17:$D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2.8284271247461903</c:v>
                  </c:pt>
                  <c:pt idx="5">
                    <c:v>0.94974746830583001</c:v>
                  </c:pt>
                  <c:pt idx="6">
                    <c:v>1.6568542494923799</c:v>
                  </c:pt>
                </c:numCache>
              </c:numRef>
            </c:minus>
          </c:errBars>
          <c:xVal>
            <c:numRef>
              <c:f>Sheet1!$B$7:$B$15</c:f>
              <c:numCache>
                <c:formatCode>General</c:formatCode>
                <c:ptCount val="9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</c:numCache>
            </c:numRef>
          </c:xVal>
          <c:yVal>
            <c:numRef>
              <c:f>Sheet1!$E$7:$E$15</c:f>
              <c:numCache>
                <c:formatCode>General</c:formatCode>
                <c:ptCount val="9"/>
                <c:pt idx="0">
                  <c:v>0</c:v>
                </c:pt>
                <c:pt idx="1">
                  <c:v>7.6642999999999999</c:v>
                </c:pt>
                <c:pt idx="2">
                  <c:v>12.4122</c:v>
                </c:pt>
                <c:pt idx="3">
                  <c:v>35.432333999999997</c:v>
                </c:pt>
                <c:pt idx="4">
                  <c:v>81.320099999999996</c:v>
                </c:pt>
                <c:pt idx="5">
                  <c:v>90.233000000000004</c:v>
                </c:pt>
                <c:pt idx="6">
                  <c:v>101.23213</c:v>
                </c:pt>
                <c:pt idx="7">
                  <c:v>102.12132</c:v>
                </c:pt>
                <c:pt idx="8">
                  <c:v>103.1232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Sheet1!$F$5:$F$6</c:f>
              <c:strCache>
                <c:ptCount val="1"/>
                <c:pt idx="0">
                  <c:v>441 1mM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F$17:$F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70710678118654757</c:v>
                  </c:pt>
                  <c:pt idx="2">
                    <c:v>2.1213203435596424</c:v>
                  </c:pt>
                  <c:pt idx="3">
                    <c:v>1.4142135623730951</c:v>
                  </c:pt>
                  <c:pt idx="4">
                    <c:v>1.4142135623730951</c:v>
                  </c:pt>
                  <c:pt idx="5">
                    <c:v>1.4142135623730951</c:v>
                  </c:pt>
                  <c:pt idx="6">
                    <c:v>1.23211</c:v>
                  </c:pt>
                </c:numCache>
              </c:numRef>
            </c:plus>
            <c:minus>
              <c:numRef>
                <c:f>Sheet1!$F$17:$F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70710678118654757</c:v>
                  </c:pt>
                  <c:pt idx="2">
                    <c:v>2.1213203435596424</c:v>
                  </c:pt>
                  <c:pt idx="3">
                    <c:v>1.4142135623730951</c:v>
                  </c:pt>
                  <c:pt idx="4">
                    <c:v>1.4142135623730951</c:v>
                  </c:pt>
                  <c:pt idx="5">
                    <c:v>1.4142135623730951</c:v>
                  </c:pt>
                  <c:pt idx="6">
                    <c:v>1.23211</c:v>
                  </c:pt>
                </c:numCache>
              </c:numRef>
            </c:minus>
          </c:errBars>
          <c:xVal>
            <c:numRef>
              <c:f>Sheet1!$B$7:$B$15</c:f>
              <c:numCache>
                <c:formatCode>General</c:formatCode>
                <c:ptCount val="9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</c:numCache>
            </c:numRef>
          </c:xVal>
          <c:yVal>
            <c:numRef>
              <c:f>Sheet1!$F$7:$F$15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.1231300000000002</c:v>
                </c:pt>
                <c:pt idx="5">
                  <c:v>14.324214</c:v>
                </c:pt>
                <c:pt idx="6">
                  <c:v>41.233199999999997</c:v>
                </c:pt>
                <c:pt idx="7">
                  <c:v>54.231310000000001</c:v>
                </c:pt>
                <c:pt idx="8">
                  <c:v>60.212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296640"/>
        <c:axId val="37059904"/>
      </c:scatterChart>
      <c:valAx>
        <c:axId val="3296640"/>
        <c:scaling>
          <c:orientation val="minMax"/>
          <c:max val="40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Time (h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37059904"/>
        <c:crosses val="autoZero"/>
        <c:crossBetween val="midCat"/>
        <c:majorUnit val="20"/>
      </c:valAx>
      <c:valAx>
        <c:axId val="37059904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/>
                  <a:t>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400"/>
            </a:pPr>
            <a:endParaRPr lang="en-US"/>
          </a:p>
        </c:txPr>
        <c:crossAx val="3296640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0073556430446189"/>
          <c:y val="4.0898950131233604E-2"/>
          <c:w val="0.85204221347331599"/>
          <c:h val="9.4128025663458709E-2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604417927636836"/>
          <c:y val="5.1400554097404488E-2"/>
          <c:w val="0.7864535013915992"/>
          <c:h val="0.80947142023913676"/>
        </c:manualLayout>
      </c:layout>
      <c:scatterChart>
        <c:scatterStyle val="lineMarker"/>
        <c:varyColors val="0"/>
        <c:ser>
          <c:idx val="0"/>
          <c:order val="0"/>
          <c:tx>
            <c:strRef>
              <c:f>'S. stipits'!$C$5:$C$6</c:f>
              <c:strCache>
                <c:ptCount val="1"/>
                <c:pt idx="0">
                  <c:v>1541 Contro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. stipits'!$C$17:$C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70710678118654757</c:v>
                  </c:pt>
                  <c:pt idx="3">
                    <c:v>3.5355339059327378</c:v>
                  </c:pt>
                  <c:pt idx="4">
                    <c:v>4.9497474683058327</c:v>
                  </c:pt>
                  <c:pt idx="5">
                    <c:v>5.6568542494923806</c:v>
                  </c:pt>
                  <c:pt idx="6">
                    <c:v>3.5355339059327378</c:v>
                  </c:pt>
                </c:numCache>
              </c:numRef>
            </c:plus>
            <c:minus>
              <c:numRef>
                <c:f>'S. stipits'!$C$17:$C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70710678118654757</c:v>
                  </c:pt>
                  <c:pt idx="3">
                    <c:v>3.5355339059327378</c:v>
                  </c:pt>
                  <c:pt idx="4">
                    <c:v>4.9497474683058327</c:v>
                  </c:pt>
                  <c:pt idx="5">
                    <c:v>5.6568542494923806</c:v>
                  </c:pt>
                  <c:pt idx="6">
                    <c:v>3.5355339059327378</c:v>
                  </c:pt>
                </c:numCache>
              </c:numRef>
            </c:minus>
          </c:errBars>
          <c:xVal>
            <c:numRef>
              <c:f>'S. stipits'!$B$7:$B$15</c:f>
              <c:numCache>
                <c:formatCode>General</c:formatCode>
                <c:ptCount val="9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</c:numCache>
            </c:numRef>
          </c:xVal>
          <c:yVal>
            <c:numRef>
              <c:f>'S. stipits'!$C$7:$C$15</c:f>
              <c:numCache>
                <c:formatCode>General</c:formatCode>
                <c:ptCount val="9"/>
                <c:pt idx="0">
                  <c:v>0</c:v>
                </c:pt>
                <c:pt idx="1">
                  <c:v>4.6666666666666679</c:v>
                </c:pt>
                <c:pt idx="2">
                  <c:v>20.666666666666668</c:v>
                </c:pt>
                <c:pt idx="3">
                  <c:v>82</c:v>
                </c:pt>
                <c:pt idx="4">
                  <c:v>98</c:v>
                </c:pt>
                <c:pt idx="5">
                  <c:v>98.666666666666671</c:v>
                </c:pt>
                <c:pt idx="6">
                  <c:v>106.00000000000001</c:v>
                </c:pt>
                <c:pt idx="7">
                  <c:v>105.66666666666667</c:v>
                </c:pt>
                <c:pt idx="8">
                  <c:v>108.6666666666666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S. stipits'!$D$5:$D$6</c:f>
              <c:strCache>
                <c:ptCount val="1"/>
                <c:pt idx="0">
                  <c:v>1541 1 mM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. stipits'!$E$17:$E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3137084989847401</c:v>
                  </c:pt>
                  <c:pt idx="2">
                    <c:v>0.87436867076455804</c:v>
                  </c:pt>
                  <c:pt idx="3">
                    <c:v>1.43502884254436</c:v>
                  </c:pt>
                  <c:pt idx="4">
                    <c:v>2.8284271247461903</c:v>
                  </c:pt>
                  <c:pt idx="5">
                    <c:v>4.9497474683058327</c:v>
                  </c:pt>
                  <c:pt idx="6">
                    <c:v>5.6568542494923806</c:v>
                  </c:pt>
                </c:numCache>
              </c:numRef>
            </c:plus>
            <c:minus>
              <c:numRef>
                <c:f>'S. stipits'!$E$17:$E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3137084989847401</c:v>
                  </c:pt>
                  <c:pt idx="2">
                    <c:v>0.87436867076455804</c:v>
                  </c:pt>
                  <c:pt idx="3">
                    <c:v>1.43502884254436</c:v>
                  </c:pt>
                  <c:pt idx="4">
                    <c:v>2.8284271247461903</c:v>
                  </c:pt>
                  <c:pt idx="5">
                    <c:v>4.9497474683058327</c:v>
                  </c:pt>
                  <c:pt idx="6">
                    <c:v>5.6568542494923806</c:v>
                  </c:pt>
                </c:numCache>
              </c:numRef>
            </c:minus>
          </c:errBars>
          <c:xVal>
            <c:numRef>
              <c:f>'S. stipits'!$B$7:$B$15</c:f>
              <c:numCache>
                <c:formatCode>General</c:formatCode>
                <c:ptCount val="9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</c:numCache>
            </c:numRef>
          </c:xVal>
          <c:yVal>
            <c:numRef>
              <c:f>'S. stipits'!$D$7:$D$15</c:f>
              <c:numCache>
                <c:formatCode>General</c:formatCode>
                <c:ptCount val="9"/>
                <c:pt idx="0">
                  <c:v>0</c:v>
                </c:pt>
                <c:pt idx="1">
                  <c:v>1.5</c:v>
                </c:pt>
                <c:pt idx="2">
                  <c:v>4</c:v>
                </c:pt>
                <c:pt idx="3">
                  <c:v>3.5</c:v>
                </c:pt>
                <c:pt idx="4">
                  <c:v>4</c:v>
                </c:pt>
                <c:pt idx="5">
                  <c:v>8</c:v>
                </c:pt>
                <c:pt idx="6">
                  <c:v>30</c:v>
                </c:pt>
                <c:pt idx="7">
                  <c:v>44.5</c:v>
                </c:pt>
                <c:pt idx="8">
                  <c:v>51.5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S. stipits'!$E$5:$E$6</c:f>
              <c:strCache>
                <c:ptCount val="1"/>
                <c:pt idx="0">
                  <c:v>1542 Contro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. stipits'!$D$17:$D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2.8284271247461903</c:v>
                  </c:pt>
                  <c:pt idx="5">
                    <c:v>0.94974746830583001</c:v>
                  </c:pt>
                  <c:pt idx="6">
                    <c:v>1.6568542494923799</c:v>
                  </c:pt>
                </c:numCache>
              </c:numRef>
            </c:plus>
            <c:minus>
              <c:numRef>
                <c:f>'S. stipits'!$D$17:$D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2.8284271247461903</c:v>
                  </c:pt>
                  <c:pt idx="5">
                    <c:v>0.94974746830583001</c:v>
                  </c:pt>
                  <c:pt idx="6">
                    <c:v>1.6568542494923799</c:v>
                  </c:pt>
                </c:numCache>
              </c:numRef>
            </c:minus>
          </c:errBars>
          <c:xVal>
            <c:numRef>
              <c:f>'S. stipits'!$B$7:$B$15</c:f>
              <c:numCache>
                <c:formatCode>General</c:formatCode>
                <c:ptCount val="9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</c:numCache>
            </c:numRef>
          </c:xVal>
          <c:yVal>
            <c:numRef>
              <c:f>'S. stipits'!$E$7:$E$15</c:f>
              <c:numCache>
                <c:formatCode>General</c:formatCode>
                <c:ptCount val="9"/>
                <c:pt idx="0">
                  <c:v>0</c:v>
                </c:pt>
                <c:pt idx="1">
                  <c:v>7.6642999999999999</c:v>
                </c:pt>
                <c:pt idx="2">
                  <c:v>17.412199999999999</c:v>
                </c:pt>
                <c:pt idx="3">
                  <c:v>67.432333999999997</c:v>
                </c:pt>
                <c:pt idx="4">
                  <c:v>91.320099999999996</c:v>
                </c:pt>
                <c:pt idx="5">
                  <c:v>90.233000000000004</c:v>
                </c:pt>
                <c:pt idx="6">
                  <c:v>101.23213</c:v>
                </c:pt>
                <c:pt idx="7">
                  <c:v>102.12132</c:v>
                </c:pt>
                <c:pt idx="8">
                  <c:v>103.1232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S. stipits'!$F$5:$F$6</c:f>
              <c:strCache>
                <c:ptCount val="1"/>
                <c:pt idx="0">
                  <c:v>1542 1 mM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. stipits'!$F$17:$F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70710678118654757</c:v>
                  </c:pt>
                  <c:pt idx="2">
                    <c:v>2.1213203435596424</c:v>
                  </c:pt>
                  <c:pt idx="3">
                    <c:v>1.4142135623730951</c:v>
                  </c:pt>
                  <c:pt idx="4">
                    <c:v>1.4142135623730951</c:v>
                  </c:pt>
                  <c:pt idx="5">
                    <c:v>1.4142135623730951</c:v>
                  </c:pt>
                  <c:pt idx="6">
                    <c:v>1.23211</c:v>
                  </c:pt>
                </c:numCache>
              </c:numRef>
            </c:plus>
            <c:minus>
              <c:numRef>
                <c:f>'S. stipits'!$F$17:$F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70710678118654757</c:v>
                  </c:pt>
                  <c:pt idx="2">
                    <c:v>2.1213203435596424</c:v>
                  </c:pt>
                  <c:pt idx="3">
                    <c:v>1.4142135623730951</c:v>
                  </c:pt>
                  <c:pt idx="4">
                    <c:v>1.4142135623730951</c:v>
                  </c:pt>
                  <c:pt idx="5">
                    <c:v>1.4142135623730951</c:v>
                  </c:pt>
                  <c:pt idx="6">
                    <c:v>1.23211</c:v>
                  </c:pt>
                </c:numCache>
              </c:numRef>
            </c:minus>
          </c:errBars>
          <c:xVal>
            <c:numRef>
              <c:f>'S. stipits'!$B$7:$B$15</c:f>
              <c:numCache>
                <c:formatCode>General</c:formatCode>
                <c:ptCount val="9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</c:numCache>
            </c:numRef>
          </c:xVal>
          <c:yVal>
            <c:numRef>
              <c:f>'S. stipits'!$F$7:$F$15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5</c:v>
                </c:pt>
                <c:pt idx="4">
                  <c:v>2.1231300000000002</c:v>
                </c:pt>
                <c:pt idx="5">
                  <c:v>6.3242139999999996</c:v>
                </c:pt>
                <c:pt idx="6">
                  <c:v>23.2332</c:v>
                </c:pt>
                <c:pt idx="7">
                  <c:v>41.231310000000001</c:v>
                </c:pt>
                <c:pt idx="8">
                  <c:v>46.212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577088"/>
        <c:axId val="81577664"/>
      </c:scatterChart>
      <c:valAx>
        <c:axId val="81577088"/>
        <c:scaling>
          <c:orientation val="minMax"/>
          <c:max val="4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1577664"/>
        <c:crosses val="autoZero"/>
        <c:crossBetween val="midCat"/>
        <c:majorUnit val="20"/>
      </c:valAx>
      <c:valAx>
        <c:axId val="81577664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157708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4426587999798915"/>
          <c:y val="2.6558361547828535E-2"/>
          <c:w val="0.85204221347331599"/>
          <c:h val="9.4128025663458709E-2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524168064743674"/>
          <c:y val="5.1400554097404488E-2"/>
          <c:w val="0.7852181357596324"/>
          <c:h val="0.80947142023913676"/>
        </c:manualLayout>
      </c:layout>
      <c:scatterChart>
        <c:scatterStyle val="lineMarker"/>
        <c:varyColors val="0"/>
        <c:ser>
          <c:idx val="0"/>
          <c:order val="0"/>
          <c:tx>
            <c:strRef>
              <c:f>'S. stipits (2)'!$C$5:$C$6</c:f>
              <c:strCache>
                <c:ptCount val="1"/>
                <c:pt idx="0">
                  <c:v>2389 Contro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. stipits (2)'!$C$17:$C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70710678118654757</c:v>
                  </c:pt>
                  <c:pt idx="3">
                    <c:v>3.5355339059327378</c:v>
                  </c:pt>
                  <c:pt idx="4">
                    <c:v>1.94974746830583</c:v>
                  </c:pt>
                  <c:pt idx="5">
                    <c:v>1.6568542494923799</c:v>
                  </c:pt>
                  <c:pt idx="6">
                    <c:v>3.5355339059327378</c:v>
                  </c:pt>
                </c:numCache>
              </c:numRef>
            </c:plus>
            <c:minus>
              <c:numRef>
                <c:f>'S. stipits (2)'!$C$17:$C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.70710678118654757</c:v>
                  </c:pt>
                  <c:pt idx="3">
                    <c:v>3.5355339059327378</c:v>
                  </c:pt>
                  <c:pt idx="4">
                    <c:v>1.94974746830583</c:v>
                  </c:pt>
                  <c:pt idx="5">
                    <c:v>1.6568542494923799</c:v>
                  </c:pt>
                  <c:pt idx="6">
                    <c:v>3.5355339059327378</c:v>
                  </c:pt>
                </c:numCache>
              </c:numRef>
            </c:minus>
          </c:errBars>
          <c:xVal>
            <c:numRef>
              <c:f>'S. stipits (2)'!$B$7:$B$16</c:f>
              <c:numCache>
                <c:formatCode>General</c:formatCode>
                <c:ptCount val="10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50</c:v>
                </c:pt>
              </c:numCache>
            </c:numRef>
          </c:xVal>
          <c:yVal>
            <c:numRef>
              <c:f>'S. stipits (2)'!$C$7:$C$1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.6666666666666661</c:v>
                </c:pt>
                <c:pt idx="4">
                  <c:v>6.6666666666666679</c:v>
                </c:pt>
                <c:pt idx="5">
                  <c:v>12</c:v>
                </c:pt>
                <c:pt idx="6">
                  <c:v>20.666666666666668</c:v>
                </c:pt>
                <c:pt idx="7">
                  <c:v>27.666666666666664</c:v>
                </c:pt>
                <c:pt idx="8">
                  <c:v>37.333333333333336</c:v>
                </c:pt>
                <c:pt idx="9">
                  <c:v>64.666666666666671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S. stipits (2)'!$D$5:$D$6</c:f>
              <c:strCache>
                <c:ptCount val="1"/>
                <c:pt idx="0">
                  <c:v>2389 1 mM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diamond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. stipits (2)'!$E$17:$E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3137084989847401</c:v>
                  </c:pt>
                  <c:pt idx="2">
                    <c:v>0.87436867076455804</c:v>
                  </c:pt>
                  <c:pt idx="3">
                    <c:v>1.43502884254436</c:v>
                  </c:pt>
                  <c:pt idx="4">
                    <c:v>0.82842712474618996</c:v>
                  </c:pt>
                  <c:pt idx="5">
                    <c:v>2.94974746830583</c:v>
                  </c:pt>
                  <c:pt idx="6">
                    <c:v>2.6568542494923801</c:v>
                  </c:pt>
                </c:numCache>
              </c:numRef>
            </c:plus>
            <c:minus>
              <c:numRef>
                <c:f>'S. stipits (2)'!$E$17:$E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1.3137084989847401</c:v>
                  </c:pt>
                  <c:pt idx="2">
                    <c:v>0.87436867076455804</c:v>
                  </c:pt>
                  <c:pt idx="3">
                    <c:v>1.43502884254436</c:v>
                  </c:pt>
                  <c:pt idx="4">
                    <c:v>0.82842712474618996</c:v>
                  </c:pt>
                  <c:pt idx="5">
                    <c:v>2.94974746830583</c:v>
                  </c:pt>
                  <c:pt idx="6">
                    <c:v>2.6568542494923801</c:v>
                  </c:pt>
                </c:numCache>
              </c:numRef>
            </c:minus>
          </c:errBars>
          <c:xVal>
            <c:numRef>
              <c:f>'S. stipits (2)'!$B$7:$B$16</c:f>
              <c:numCache>
                <c:formatCode>General</c:formatCode>
                <c:ptCount val="10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50</c:v>
                </c:pt>
              </c:numCache>
            </c:numRef>
          </c:xVal>
          <c:yVal>
            <c:numRef>
              <c:f>'S. stipits (2)'!$D$7:$D$1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33333333333333393</c:v>
                </c:pt>
                <c:pt idx="6">
                  <c:v>2</c:v>
                </c:pt>
                <c:pt idx="7">
                  <c:v>2</c:v>
                </c:pt>
                <c:pt idx="8">
                  <c:v>3.3333333333333339</c:v>
                </c:pt>
                <c:pt idx="9">
                  <c:v>11.333333333333332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S. stipits (2)'!$E$5:$E$6</c:f>
              <c:strCache>
                <c:ptCount val="1"/>
                <c:pt idx="0">
                  <c:v>3781 Control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. stipits (2)'!$D$17:$D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2.8284271247461903</c:v>
                  </c:pt>
                  <c:pt idx="5">
                    <c:v>0.94974746830583001</c:v>
                  </c:pt>
                  <c:pt idx="6">
                    <c:v>1.6568542494923799</c:v>
                  </c:pt>
                </c:numCache>
              </c:numRef>
            </c:plus>
            <c:minus>
              <c:numRef>
                <c:f>'S. stipits (2)'!$D$17:$D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2.8284271247461903</c:v>
                  </c:pt>
                  <c:pt idx="5">
                    <c:v>0.94974746830583001</c:v>
                  </c:pt>
                  <c:pt idx="6">
                    <c:v>1.6568542494923799</c:v>
                  </c:pt>
                </c:numCache>
              </c:numRef>
            </c:minus>
          </c:errBars>
          <c:xVal>
            <c:numRef>
              <c:f>'S. stipits (2)'!$B$7:$B$16</c:f>
              <c:numCache>
                <c:formatCode>General</c:formatCode>
                <c:ptCount val="10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50</c:v>
                </c:pt>
              </c:numCache>
            </c:numRef>
          </c:xVal>
          <c:yVal>
            <c:numRef>
              <c:f>'S. stipits (2)'!$E$7:$E$1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66333</c:v>
                </c:pt>
                <c:pt idx="4">
                  <c:v>4.11111</c:v>
                </c:pt>
                <c:pt idx="5">
                  <c:v>8.3421409999999998</c:v>
                </c:pt>
                <c:pt idx="6">
                  <c:v>16.234241999999998</c:v>
                </c:pt>
                <c:pt idx="7">
                  <c:v>23.112221000000002</c:v>
                </c:pt>
                <c:pt idx="8">
                  <c:v>35.122219999999999</c:v>
                </c:pt>
                <c:pt idx="9">
                  <c:v>60.121209999999998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S. stipits (2)'!$F$5:$F$6</c:f>
              <c:strCache>
                <c:ptCount val="1"/>
                <c:pt idx="0">
                  <c:v>3781 1 mM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noFill/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S. stipits (2)'!$F$17:$F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70710678118654757</c:v>
                  </c:pt>
                  <c:pt idx="2">
                    <c:v>2.1213203435596424</c:v>
                  </c:pt>
                  <c:pt idx="3">
                    <c:v>1.4142135623730951</c:v>
                  </c:pt>
                  <c:pt idx="4">
                    <c:v>1.4142135623730951</c:v>
                  </c:pt>
                  <c:pt idx="5">
                    <c:v>1.4142135623730951</c:v>
                  </c:pt>
                  <c:pt idx="6">
                    <c:v>1.23211</c:v>
                  </c:pt>
                </c:numCache>
              </c:numRef>
            </c:plus>
            <c:minus>
              <c:numRef>
                <c:f>'S. stipits (2)'!$F$17:$F$23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.70710678118654757</c:v>
                  </c:pt>
                  <c:pt idx="2">
                    <c:v>2.1213203435596424</c:v>
                  </c:pt>
                  <c:pt idx="3">
                    <c:v>1.4142135623730951</c:v>
                  </c:pt>
                  <c:pt idx="4">
                    <c:v>1.4142135623730951</c:v>
                  </c:pt>
                  <c:pt idx="5">
                    <c:v>1.4142135623730951</c:v>
                  </c:pt>
                  <c:pt idx="6">
                    <c:v>1.23211</c:v>
                  </c:pt>
                </c:numCache>
              </c:numRef>
            </c:minus>
          </c:errBars>
          <c:xVal>
            <c:numRef>
              <c:f>'S. stipits (2)'!$B$7:$B$16</c:f>
              <c:numCache>
                <c:formatCode>General</c:formatCode>
                <c:ptCount val="10"/>
                <c:pt idx="0">
                  <c:v>0</c:v>
                </c:pt>
                <c:pt idx="1">
                  <c:v>5</c:v>
                </c:pt>
                <c:pt idx="2">
                  <c:v>10</c:v>
                </c:pt>
                <c:pt idx="3">
                  <c:v>15</c:v>
                </c:pt>
                <c:pt idx="4">
                  <c:v>20</c:v>
                </c:pt>
                <c:pt idx="5">
                  <c:v>25</c:v>
                </c:pt>
                <c:pt idx="6">
                  <c:v>30</c:v>
                </c:pt>
                <c:pt idx="7">
                  <c:v>35</c:v>
                </c:pt>
                <c:pt idx="8">
                  <c:v>40</c:v>
                </c:pt>
                <c:pt idx="9">
                  <c:v>50</c:v>
                </c:pt>
              </c:numCache>
            </c:numRef>
          </c:xVal>
          <c:yVal>
            <c:numRef>
              <c:f>'S. stipits (2)'!$F$7:$F$1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</c:v>
                </c:pt>
                <c:pt idx="8">
                  <c:v>1.454253</c:v>
                </c:pt>
                <c:pt idx="9">
                  <c:v>9.0122199999999992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1579392"/>
        <c:axId val="81579968"/>
      </c:scatterChart>
      <c:valAx>
        <c:axId val="81579392"/>
        <c:scaling>
          <c:orientation val="minMax"/>
          <c:max val="5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1579968"/>
        <c:crosses val="autoZero"/>
        <c:crossBetween val="midCat"/>
        <c:majorUnit val="10"/>
      </c:valAx>
      <c:valAx>
        <c:axId val="81579968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dox signal intens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81579392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8018154347701751"/>
          <c:y val="4.0898950131233604E-2"/>
          <c:w val="0.77259612176615255"/>
          <c:h val="0.11699060186728223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77A05-3DB8-48ED-8900-64AE6B0193AB}" type="datetimeFigureOut">
              <a:rPr lang="en-GB" smtClean="0"/>
              <a:t>05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4F3B-CF19-4E97-8F26-A643CF328A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97494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77A05-3DB8-48ED-8900-64AE6B0193AB}" type="datetimeFigureOut">
              <a:rPr lang="en-GB" smtClean="0"/>
              <a:t>05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4F3B-CF19-4E97-8F26-A643CF328A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1737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77A05-3DB8-48ED-8900-64AE6B0193AB}" type="datetimeFigureOut">
              <a:rPr lang="en-GB" smtClean="0"/>
              <a:t>05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4F3B-CF19-4E97-8F26-A643CF328A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40107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77A05-3DB8-48ED-8900-64AE6B0193AB}" type="datetimeFigureOut">
              <a:rPr lang="en-GB" smtClean="0"/>
              <a:t>05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4F3B-CF19-4E97-8F26-A643CF328A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27972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77A05-3DB8-48ED-8900-64AE6B0193AB}" type="datetimeFigureOut">
              <a:rPr lang="en-GB" smtClean="0"/>
              <a:t>05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4F3B-CF19-4E97-8F26-A643CF328A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54667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77A05-3DB8-48ED-8900-64AE6B0193AB}" type="datetimeFigureOut">
              <a:rPr lang="en-GB" smtClean="0"/>
              <a:t>05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4F3B-CF19-4E97-8F26-A643CF328A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56833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77A05-3DB8-48ED-8900-64AE6B0193AB}" type="datetimeFigureOut">
              <a:rPr lang="en-GB" smtClean="0"/>
              <a:t>05/07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4F3B-CF19-4E97-8F26-A643CF328A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0654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77A05-3DB8-48ED-8900-64AE6B0193AB}" type="datetimeFigureOut">
              <a:rPr lang="en-GB" smtClean="0"/>
              <a:t>05/07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4F3B-CF19-4E97-8F26-A643CF328A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7893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77A05-3DB8-48ED-8900-64AE6B0193AB}" type="datetimeFigureOut">
              <a:rPr lang="en-GB" smtClean="0"/>
              <a:t>05/07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4F3B-CF19-4E97-8F26-A643CF328A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1319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77A05-3DB8-48ED-8900-64AE6B0193AB}" type="datetimeFigureOut">
              <a:rPr lang="en-GB" smtClean="0"/>
              <a:t>05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4F3B-CF19-4E97-8F26-A643CF328A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49531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C77A05-3DB8-48ED-8900-64AE6B0193AB}" type="datetimeFigureOut">
              <a:rPr lang="en-GB" smtClean="0"/>
              <a:t>05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4F4F3B-CF19-4E97-8F26-A643CF328A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0656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C77A05-3DB8-48ED-8900-64AE6B0193AB}" type="datetimeFigureOut">
              <a:rPr lang="en-GB" smtClean="0"/>
              <a:t>05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4F4F3B-CF19-4E97-8F26-A643CF328AF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6301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8340696"/>
              </p:ext>
            </p:extLst>
          </p:nvPr>
        </p:nvGraphicFramePr>
        <p:xfrm>
          <a:off x="0" y="0"/>
          <a:ext cx="3356992" cy="44999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0" y="301848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/>
              <a:t>A</a:t>
            </a:r>
            <a:endParaRPr lang="en-GB" sz="20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3501008" y="307522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/>
              <a:t>B</a:t>
            </a:r>
            <a:endParaRPr lang="en-GB" sz="2000" b="1" dirty="0"/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4437523"/>
              </p:ext>
            </p:extLst>
          </p:nvPr>
        </p:nvGraphicFramePr>
        <p:xfrm>
          <a:off x="3356993" y="0"/>
          <a:ext cx="3501008" cy="442798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8024495"/>
              </p:ext>
            </p:extLst>
          </p:nvPr>
        </p:nvGraphicFramePr>
        <p:xfrm>
          <a:off x="0" y="4283968"/>
          <a:ext cx="3356992" cy="38884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0" y="4499992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dirty="0" smtClean="0"/>
              <a:t>C</a:t>
            </a:r>
            <a:endParaRPr lang="en-GB" sz="2000" b="1" dirty="0"/>
          </a:p>
        </p:txBody>
      </p:sp>
    </p:spTree>
    <p:extLst>
      <p:ext uri="{BB962C8B-B14F-4D97-AF65-F5344CB8AC3E}">
        <p14:creationId xmlns:p14="http://schemas.microsoft.com/office/powerpoint/2010/main" val="1085138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3</TotalTime>
  <Words>24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Nott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reetham Darren</dc:creator>
  <cp:lastModifiedBy>Greetham Darren</cp:lastModifiedBy>
  <cp:revision>13</cp:revision>
  <dcterms:created xsi:type="dcterms:W3CDTF">2013-07-03T14:57:25Z</dcterms:created>
  <dcterms:modified xsi:type="dcterms:W3CDTF">2013-07-05T14:07:03Z</dcterms:modified>
</cp:coreProperties>
</file>